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FEF4D9F-9049-9549-9D5E-B30FCB21AF6D}" v="3" dt="2025-01-06T10:52:01.6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1" autoAdjust="0"/>
    <p:restoredTop sz="94660"/>
  </p:normalViewPr>
  <p:slideViewPr>
    <p:cSldViewPr snapToGrid="0">
      <p:cViewPr varScale="1">
        <p:scale>
          <a:sx n="97" d="100"/>
          <a:sy n="97" d="100"/>
        </p:scale>
        <p:origin x="216" y="8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ina Dikovskaya (Staff)" userId="8d8a7ac9-8c04-4e92-b78e-9920f50eab52" providerId="ADAL" clId="{FFEF4D9F-9049-9549-9D5E-B30FCB21AF6D}"/>
    <pc:docChg chg="modSld">
      <pc:chgData name="Dina Dikovskaya (Staff)" userId="8d8a7ac9-8c04-4e92-b78e-9920f50eab52" providerId="ADAL" clId="{FFEF4D9F-9049-9549-9D5E-B30FCB21AF6D}" dt="2025-01-06T10:52:09.572" v="17" actId="1076"/>
      <pc:docMkLst>
        <pc:docMk/>
      </pc:docMkLst>
      <pc:sldChg chg="addSp modSp mod">
        <pc:chgData name="Dina Dikovskaya (Staff)" userId="8d8a7ac9-8c04-4e92-b78e-9920f50eab52" providerId="ADAL" clId="{FFEF4D9F-9049-9549-9D5E-B30FCB21AF6D}" dt="2025-01-06T10:52:09.572" v="17" actId="1076"/>
        <pc:sldMkLst>
          <pc:docMk/>
          <pc:sldMk cId="2915354396" sldId="256"/>
        </pc:sldMkLst>
        <pc:spChg chg="add mod">
          <ac:chgData name="Dina Dikovskaya (Staff)" userId="8d8a7ac9-8c04-4e92-b78e-9920f50eab52" providerId="ADAL" clId="{FFEF4D9F-9049-9549-9D5E-B30FCB21AF6D}" dt="2025-01-06T10:51:10.673" v="3" actId="692"/>
          <ac:spMkLst>
            <pc:docMk/>
            <pc:sldMk cId="2915354396" sldId="256"/>
            <ac:spMk id="6" creationId="{1D8B063A-5C30-F86A-BE30-9949376B783C}"/>
          </ac:spMkLst>
        </pc:spChg>
        <pc:spChg chg="add mod">
          <ac:chgData name="Dina Dikovskaya (Staff)" userId="8d8a7ac9-8c04-4e92-b78e-9920f50eab52" providerId="ADAL" clId="{FFEF4D9F-9049-9549-9D5E-B30FCB21AF6D}" dt="2025-01-06T10:51:52.250" v="13" actId="1036"/>
          <ac:spMkLst>
            <pc:docMk/>
            <pc:sldMk cId="2915354396" sldId="256"/>
            <ac:spMk id="9" creationId="{01A5AEBB-1384-6906-8AC6-47F265C6B6BF}"/>
          </ac:spMkLst>
        </pc:spChg>
        <pc:spChg chg="add mod">
          <ac:chgData name="Dina Dikovskaya (Staff)" userId="8d8a7ac9-8c04-4e92-b78e-9920f50eab52" providerId="ADAL" clId="{FFEF4D9F-9049-9549-9D5E-B30FCB21AF6D}" dt="2025-01-06T10:51:59.095" v="15" actId="1076"/>
          <ac:spMkLst>
            <pc:docMk/>
            <pc:sldMk cId="2915354396" sldId="256"/>
            <ac:spMk id="22" creationId="{2567E264-090B-E9A6-8CD6-B63E1DD4ECDC}"/>
          </ac:spMkLst>
        </pc:spChg>
        <pc:spChg chg="add mod">
          <ac:chgData name="Dina Dikovskaya (Staff)" userId="8d8a7ac9-8c04-4e92-b78e-9920f50eab52" providerId="ADAL" clId="{FFEF4D9F-9049-9549-9D5E-B30FCB21AF6D}" dt="2025-01-06T10:52:09.572" v="17" actId="1076"/>
          <ac:spMkLst>
            <pc:docMk/>
            <pc:sldMk cId="2915354396" sldId="256"/>
            <ac:spMk id="23" creationId="{90D75FD9-D5EB-5CBA-73F3-00F56FF5F79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059D4D-2326-69AF-EAD9-695513F455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151901-3991-1FC9-D588-BBCB2DD0B1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9F7E1D-3A7F-0C69-C91F-C486403D2E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5CAC7B-99F8-4745-8394-DA65D8722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7CB122-F2B1-63BD-D5C5-D61D5BD22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3315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2666CB-CF9A-AAD7-6100-11E60C9B1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5E3CCF-3F07-AFE3-758C-733E529743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C183E2-B808-CD62-65C0-849187959C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0D6AE9-CBAF-289E-98CA-6BDFACEFF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1A65D2-7D4F-E541-8930-F3A4A5963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3609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CD62B8-9A07-E7E2-D111-9E98CC0BAB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297020E-078D-AB05-C277-022386C8D3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17042-2532-2C98-5CF3-5E862CD36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6A2E4C-E1CC-AEC9-53B7-CE2131AF7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F54120-F27A-5F84-AB1F-49BE71D0B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2912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30F399-6877-91CB-84AA-50AB44E28B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374999-3DBF-3052-2C0B-68D079D5EA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6C0522-331A-2D54-5068-691F131B4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ABB7A9-AFB4-C87D-E4A0-D73C4549D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1FF6C2-B9EE-80E8-7463-BA56384EC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9391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FEF5B0-5401-3D30-4ADE-211BEE0899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089F32-F04F-0F55-55D9-CA550003B3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4F15B1-1619-FEDD-90BA-1995087FE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945811-27D8-730B-DA71-5B483B4B7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29E5A7-4BEB-866F-4E2D-1306C82C8A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154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E3F3C-CF82-C2D4-3594-804F11026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248A06-061D-5298-76F3-AA1DE0E7F9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7C8ACC-D8E0-459E-61A6-BC39BC9AB5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E39A72-C56E-D983-7271-B44ABE6073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92549E-E64A-963B-3702-7D69AEF097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7B69E-BD51-4583-992E-E85A10B193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537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6D6D1A-4519-FF8B-3F71-0CDD94556E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3BA9FC-0152-7ECC-F8E9-B66BB8D885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38B6C1-31C5-F01C-42C4-55CBB6B3DD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96FD16-355A-0786-832A-64E27C8F0D8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8A60AB-1B99-5837-8C5A-D64A0F6383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973DBE-7000-5960-7FA7-288E945F31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42FCE7-A750-543E-5ABB-E634C0840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57155F-190C-F5B2-8859-F38C2B45C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9642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DDA4B-C819-1DEF-2C27-7AD2D3503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E5CD238-A64A-A081-2C27-E10229B4F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57666C-BD22-1BAA-5477-08909D70A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C1140C-BF4A-3F1F-1698-91D030E5B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1971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3508DA-E481-B790-CC75-F19101A7E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8B7DA3-7890-2174-C333-6A7F39362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902ED1-9F0C-8199-336C-46EC33AF1C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4110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D34C5-512B-3E34-27CE-F5E391C448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A8D3FB-ADBB-5EEF-4B0B-2FAD0C259C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D6037A-7F75-BA7A-91D6-06626AE2FC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9FC781-729C-879D-2A8A-8D8479787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29C1473-FD28-E1FE-8427-9AD3E1B6D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AE8DB7-060C-CA00-9AB9-26722C2082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3951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3AF2E8-488E-6134-69DB-D220D2F06D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464D352-35EF-9A69-CF6A-8DA49B21B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B9896E-9616-5C46-E66D-672DF5671D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F6A219-14BD-6ACF-7221-140B0C7FB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B845D9-79AA-3991-79BD-3772AE491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9E6049-6497-C513-57D0-151EE8C7D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72753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30FCFD9-07A8-6ACE-FC7B-F32B93C042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1E0E6F7-B157-EC09-C1B2-E9334D9EA2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3B130B-AB47-8E23-8891-F26325B646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4E52E3-B5CF-47BC-8992-9E323BCC5AEE}" type="datetimeFigureOut">
              <a:rPr lang="en-GB" smtClean="0"/>
              <a:t>06/0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73BD69-FAB4-5EE1-410B-BCE6CCF436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8B0A8F-5B18-BE4B-E3EF-431C1D8078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94B8E9-2544-4671-84C1-26CC0F64A2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0659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75769D6D-7036-02CA-75D8-34AF04423E27}"/>
              </a:ext>
            </a:extLst>
          </p:cNvPr>
          <p:cNvSpPr txBox="1"/>
          <p:nvPr/>
        </p:nvSpPr>
        <p:spPr>
          <a:xfrm>
            <a:off x="6143622" y="3959343"/>
            <a:ext cx="12971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pT73 Rab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381EB87-E2F7-1CB0-A80B-1ECA522F3560}"/>
              </a:ext>
            </a:extLst>
          </p:cNvPr>
          <p:cNvSpPr txBox="1"/>
          <p:nvPr/>
        </p:nvSpPr>
        <p:spPr>
          <a:xfrm>
            <a:off x="6137210" y="4888819"/>
            <a:ext cx="1263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otal Rab10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4215C19-ECC8-2E04-554B-A2C116C8906B}"/>
              </a:ext>
            </a:extLst>
          </p:cNvPr>
          <p:cNvGrpSpPr/>
          <p:nvPr/>
        </p:nvGrpSpPr>
        <p:grpSpPr>
          <a:xfrm>
            <a:off x="1856232" y="2627681"/>
            <a:ext cx="4287390" cy="3782262"/>
            <a:chOff x="3848100" y="2285908"/>
            <a:chExt cx="2295522" cy="2559184"/>
          </a:xfrm>
        </p:grpSpPr>
        <p:pic>
          <p:nvPicPr>
            <p:cNvPr id="5" name="Picture 4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5479E024-0E73-B546-2379-A768285D84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35" t="16964" r="17906" b="67975"/>
            <a:stretch/>
          </p:blipFill>
          <p:spPr>
            <a:xfrm>
              <a:off x="3895724" y="3037445"/>
              <a:ext cx="2200275" cy="590550"/>
            </a:xfrm>
            <a:prstGeom prst="rect">
              <a:avLst/>
            </a:prstGeom>
          </p:spPr>
        </p:pic>
        <p:pic>
          <p:nvPicPr>
            <p:cNvPr id="8" name="Picture 7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6ADD5CA1-A9D8-C6AB-A8A8-1275B8BCCE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92" t="14983" r="17029" b="69957"/>
            <a:stretch/>
          </p:blipFill>
          <p:spPr>
            <a:xfrm>
              <a:off x="3895725" y="3678793"/>
              <a:ext cx="2200275" cy="590550"/>
            </a:xfrm>
            <a:prstGeom prst="rect">
              <a:avLst/>
            </a:prstGeom>
          </p:spPr>
        </p:pic>
        <p:pic>
          <p:nvPicPr>
            <p:cNvPr id="13" name="Picture 12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A480871C-BF72-6216-2863-87193A3FC8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88" t="73694" r="12972" b="10517"/>
            <a:stretch/>
          </p:blipFill>
          <p:spPr>
            <a:xfrm>
              <a:off x="3895724" y="2285908"/>
              <a:ext cx="2247898" cy="619125"/>
            </a:xfrm>
            <a:prstGeom prst="rect">
              <a:avLst/>
            </a:prstGeom>
          </p:spPr>
        </p:pic>
        <p:pic>
          <p:nvPicPr>
            <p:cNvPr id="14" name="Picture 13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9F90316C-C4E5-4108-C3BE-87AEE5EA93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88" t="46920" r="12972" b="40610"/>
            <a:stretch/>
          </p:blipFill>
          <p:spPr>
            <a:xfrm>
              <a:off x="3848100" y="4356141"/>
              <a:ext cx="2247898" cy="488951"/>
            </a:xfrm>
            <a:prstGeom prst="rect">
              <a:avLst/>
            </a:prstGeom>
          </p:spPr>
        </p:pic>
      </p:grpSp>
      <p:sp>
        <p:nvSpPr>
          <p:cNvPr id="15" name="TextBox 14">
            <a:extLst>
              <a:ext uri="{FF2B5EF4-FFF2-40B4-BE49-F238E27FC236}">
                <a16:creationId xmlns:a16="http://schemas.microsoft.com/office/drawing/2014/main" id="{D8220D31-EC4F-6F1B-03C1-D1D6D79DB052}"/>
              </a:ext>
            </a:extLst>
          </p:cNvPr>
          <p:cNvSpPr txBox="1"/>
          <p:nvPr/>
        </p:nvSpPr>
        <p:spPr>
          <a:xfrm rot="16200000" flipH="1">
            <a:off x="2331054" y="1773760"/>
            <a:ext cx="1512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Parental MODE-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5ABF005-22AC-8C45-5DD2-CBFA2E327E22}"/>
              </a:ext>
            </a:extLst>
          </p:cNvPr>
          <p:cNvSpPr txBox="1"/>
          <p:nvPr/>
        </p:nvSpPr>
        <p:spPr>
          <a:xfrm rot="16200000">
            <a:off x="3168661" y="2040162"/>
            <a:ext cx="979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LRRK2-K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592D818-527F-39A0-B05A-455B45723BF6}"/>
              </a:ext>
            </a:extLst>
          </p:cNvPr>
          <p:cNvSpPr txBox="1"/>
          <p:nvPr/>
        </p:nvSpPr>
        <p:spPr>
          <a:xfrm>
            <a:off x="6271862" y="2744489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LRRK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E38E9AE-0F87-5EF8-2935-AE46968A4278}"/>
              </a:ext>
            </a:extLst>
          </p:cNvPr>
          <p:cNvSpPr txBox="1"/>
          <p:nvPr/>
        </p:nvSpPr>
        <p:spPr>
          <a:xfrm>
            <a:off x="6107154" y="6040612"/>
            <a:ext cx="875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ubuli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897211-3101-A26B-2E4C-166988DFDB90}"/>
              </a:ext>
            </a:extLst>
          </p:cNvPr>
          <p:cNvSpPr txBox="1"/>
          <p:nvPr/>
        </p:nvSpPr>
        <p:spPr>
          <a:xfrm rot="16200000">
            <a:off x="3693937" y="2004032"/>
            <a:ext cx="10515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LRRK2-W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D2577D2-02C6-0647-1667-A8B5A5F2BE0B}"/>
              </a:ext>
            </a:extLst>
          </p:cNvPr>
          <p:cNvSpPr txBox="1"/>
          <p:nvPr/>
        </p:nvSpPr>
        <p:spPr>
          <a:xfrm rot="16200000">
            <a:off x="4856017" y="2049540"/>
            <a:ext cx="960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Splenocyte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28A27E-F169-86D8-C5FF-5D9CDF66E6D6}"/>
              </a:ext>
            </a:extLst>
          </p:cNvPr>
          <p:cNvSpPr txBox="1"/>
          <p:nvPr/>
        </p:nvSpPr>
        <p:spPr>
          <a:xfrm rot="16200000" flipH="1">
            <a:off x="1781089" y="1773760"/>
            <a:ext cx="15120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mark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7314B56-CB64-D74B-1F7D-CA617115E66D}"/>
              </a:ext>
            </a:extLst>
          </p:cNvPr>
          <p:cNvSpPr txBox="1"/>
          <p:nvPr/>
        </p:nvSpPr>
        <p:spPr>
          <a:xfrm>
            <a:off x="1060178" y="2743201"/>
            <a:ext cx="9621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0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0A2AAF8-ECE0-30B2-DDE3-A5E37AB0761B}"/>
              </a:ext>
            </a:extLst>
          </p:cNvPr>
          <p:cNvSpPr txBox="1"/>
          <p:nvPr/>
        </p:nvSpPr>
        <p:spPr>
          <a:xfrm>
            <a:off x="1186070" y="4817166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5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AB15277-1BC4-2609-C4D4-9805D732A1C5}"/>
              </a:ext>
            </a:extLst>
          </p:cNvPr>
          <p:cNvSpPr txBox="1"/>
          <p:nvPr/>
        </p:nvSpPr>
        <p:spPr>
          <a:xfrm>
            <a:off x="1192695" y="5115340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0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A65C26D-31D6-5196-8371-0755D73F3E8D}"/>
              </a:ext>
            </a:extLst>
          </p:cNvPr>
          <p:cNvSpPr txBox="1"/>
          <p:nvPr/>
        </p:nvSpPr>
        <p:spPr>
          <a:xfrm>
            <a:off x="1093307" y="5943601"/>
            <a:ext cx="8451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0 </a:t>
            </a:r>
            <a:r>
              <a:rPr lang="en-US" dirty="0" err="1"/>
              <a:t>KDa</a:t>
            </a:r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D8B063A-5C30-F86A-BE30-9949376B783C}"/>
              </a:ext>
            </a:extLst>
          </p:cNvPr>
          <p:cNvSpPr/>
          <p:nvPr/>
        </p:nvSpPr>
        <p:spPr>
          <a:xfrm>
            <a:off x="2853732" y="2662813"/>
            <a:ext cx="1627833" cy="411983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01A5AEBB-1384-6906-8AC6-47F265C6B6BF}"/>
              </a:ext>
            </a:extLst>
          </p:cNvPr>
          <p:cNvSpPr/>
          <p:nvPr/>
        </p:nvSpPr>
        <p:spPr>
          <a:xfrm>
            <a:off x="2688080" y="3875387"/>
            <a:ext cx="1724894" cy="411983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567E264-090B-E9A6-8CD6-B63E1DD4ECDC}"/>
              </a:ext>
            </a:extLst>
          </p:cNvPr>
          <p:cNvSpPr/>
          <p:nvPr/>
        </p:nvSpPr>
        <p:spPr>
          <a:xfrm>
            <a:off x="2694706" y="4928935"/>
            <a:ext cx="1724894" cy="411983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90D75FD9-D5EB-5CBA-73F3-00F56FF5F796}"/>
              </a:ext>
            </a:extLst>
          </p:cNvPr>
          <p:cNvSpPr/>
          <p:nvPr/>
        </p:nvSpPr>
        <p:spPr>
          <a:xfrm>
            <a:off x="2615193" y="5922848"/>
            <a:ext cx="1724894" cy="411983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3543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0</Words>
  <Application>Microsoft Macintosh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Dunde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Pemberton (PG Research)</dc:creator>
  <cp:lastModifiedBy>Dina Dikovskaya (Staff)</cp:lastModifiedBy>
  <cp:revision>3</cp:revision>
  <dcterms:created xsi:type="dcterms:W3CDTF">2023-11-09T09:05:58Z</dcterms:created>
  <dcterms:modified xsi:type="dcterms:W3CDTF">2025-01-06T10:52:11Z</dcterms:modified>
</cp:coreProperties>
</file>